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82" r:id="rId2"/>
  </p:sldIdLst>
  <p:sldSz cx="16916400" cy="21945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1320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ranz, Alexander" userId="302c93c3-6320-4d3c-a68d-a1fdc247d2f3" providerId="ADAL" clId="{A9D1BA43-E41A-40EF-94A4-5367FB56CB6C}"/>
    <pc:docChg chg="modSld">
      <pc:chgData name="Franz, Alexander" userId="302c93c3-6320-4d3c-a68d-a1fdc247d2f3" providerId="ADAL" clId="{A9D1BA43-E41A-40EF-94A4-5367FB56CB6C}" dt="2025-05-09T15:17:54.196" v="0" actId="207"/>
      <pc:docMkLst>
        <pc:docMk/>
      </pc:docMkLst>
      <pc:sldChg chg="modSp mod">
        <pc:chgData name="Franz, Alexander" userId="302c93c3-6320-4d3c-a68d-a1fdc247d2f3" providerId="ADAL" clId="{A9D1BA43-E41A-40EF-94A4-5367FB56CB6C}" dt="2025-05-09T15:17:54.196" v="0" actId="207"/>
        <pc:sldMkLst>
          <pc:docMk/>
          <pc:sldMk cId="1558593817" sldId="282"/>
        </pc:sldMkLst>
        <pc:spChg chg="mod">
          <ac:chgData name="Franz, Alexander" userId="302c93c3-6320-4d3c-a68d-a1fdc247d2f3" providerId="ADAL" clId="{A9D1BA43-E41A-40EF-94A4-5367FB56CB6C}" dt="2025-05-09T15:17:54.196" v="0" actId="207"/>
          <ac:spMkLst>
            <pc:docMk/>
            <pc:sldMk cId="1558593817" sldId="282"/>
            <ac:spMk id="5" creationId="{7AE735D4-45B6-2200-C2BC-DFB554058BE4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2EB3E9-7FC1-4091-982A-3ED580D49C5A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143000"/>
            <a:ext cx="2378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D2B3F1-9DE9-4B62-87EA-66A776D0C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6059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1pPr>
    <a:lvl2pPr marL="563179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2pPr>
    <a:lvl3pPr marL="1126358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3pPr>
    <a:lvl4pPr marL="1689537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4pPr>
    <a:lvl5pPr marL="2252716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5pPr>
    <a:lvl6pPr marL="2815895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6pPr>
    <a:lvl7pPr marL="3379074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7pPr>
    <a:lvl8pPr marL="3942253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8pPr>
    <a:lvl9pPr marL="4505432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68730" y="3591562"/>
            <a:ext cx="14378940" cy="7640320"/>
          </a:xfrm>
        </p:spPr>
        <p:txBody>
          <a:bodyPr anchor="b"/>
          <a:lstStyle>
            <a:lvl1pPr algn="ctr">
              <a:defRPr sz="11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114550" y="11526522"/>
            <a:ext cx="12687300" cy="5298438"/>
          </a:xfrm>
        </p:spPr>
        <p:txBody>
          <a:bodyPr/>
          <a:lstStyle>
            <a:lvl1pPr marL="0" indent="0" algn="ctr">
              <a:buNone/>
              <a:defRPr sz="4440"/>
            </a:lvl1pPr>
            <a:lvl2pPr marL="845820" indent="0" algn="ctr">
              <a:buNone/>
              <a:defRPr sz="3700"/>
            </a:lvl2pPr>
            <a:lvl3pPr marL="1691640" indent="0" algn="ctr">
              <a:buNone/>
              <a:defRPr sz="3330"/>
            </a:lvl3pPr>
            <a:lvl4pPr marL="2537460" indent="0" algn="ctr">
              <a:buNone/>
              <a:defRPr sz="2960"/>
            </a:lvl4pPr>
            <a:lvl5pPr marL="3383280" indent="0" algn="ctr">
              <a:buNone/>
              <a:defRPr sz="2960"/>
            </a:lvl5pPr>
            <a:lvl6pPr marL="4229100" indent="0" algn="ctr">
              <a:buNone/>
              <a:defRPr sz="2960"/>
            </a:lvl6pPr>
            <a:lvl7pPr marL="5074920" indent="0" algn="ctr">
              <a:buNone/>
              <a:defRPr sz="2960"/>
            </a:lvl7pPr>
            <a:lvl8pPr marL="5920740" indent="0" algn="ctr">
              <a:buNone/>
              <a:defRPr sz="2960"/>
            </a:lvl8pPr>
            <a:lvl9pPr marL="6766560" indent="0" algn="ctr">
              <a:buNone/>
              <a:defRPr sz="29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464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626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105800" y="1168400"/>
            <a:ext cx="3647599" cy="1859788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63004" y="1168400"/>
            <a:ext cx="10731341" cy="1859788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074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658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193" y="5471167"/>
            <a:ext cx="14590395" cy="9128758"/>
          </a:xfrm>
        </p:spPr>
        <p:txBody>
          <a:bodyPr anchor="b"/>
          <a:lstStyle>
            <a:lvl1pPr>
              <a:defRPr sz="11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193" y="14686287"/>
            <a:ext cx="14590395" cy="4800598"/>
          </a:xfrm>
        </p:spPr>
        <p:txBody>
          <a:bodyPr/>
          <a:lstStyle>
            <a:lvl1pPr marL="0" indent="0">
              <a:buNone/>
              <a:defRPr sz="4440">
                <a:solidFill>
                  <a:schemeClr val="tx1">
                    <a:tint val="82000"/>
                  </a:schemeClr>
                </a:solidFill>
              </a:defRPr>
            </a:lvl1pPr>
            <a:lvl2pPr marL="845820" indent="0">
              <a:buNone/>
              <a:defRPr sz="3700">
                <a:solidFill>
                  <a:schemeClr val="tx1">
                    <a:tint val="82000"/>
                  </a:schemeClr>
                </a:solidFill>
              </a:defRPr>
            </a:lvl2pPr>
            <a:lvl3pPr marL="1691640" indent="0">
              <a:buNone/>
              <a:defRPr sz="3330">
                <a:solidFill>
                  <a:schemeClr val="tx1">
                    <a:tint val="82000"/>
                  </a:schemeClr>
                </a:solidFill>
              </a:defRPr>
            </a:lvl3pPr>
            <a:lvl4pPr marL="253746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4pPr>
            <a:lvl5pPr marL="338328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5pPr>
            <a:lvl6pPr marL="422910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6pPr>
            <a:lvl7pPr marL="507492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7pPr>
            <a:lvl8pPr marL="592074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8pPr>
            <a:lvl9pPr marL="676656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913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63003" y="5842000"/>
            <a:ext cx="718947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563928" y="5842000"/>
            <a:ext cx="718947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628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168405"/>
            <a:ext cx="14590395" cy="42418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65208" y="5379722"/>
            <a:ext cx="7156429" cy="2636518"/>
          </a:xfrm>
        </p:spPr>
        <p:txBody>
          <a:bodyPr anchor="b"/>
          <a:lstStyle>
            <a:lvl1pPr marL="0" indent="0">
              <a:buNone/>
              <a:defRPr sz="4440" b="1"/>
            </a:lvl1pPr>
            <a:lvl2pPr marL="845820" indent="0">
              <a:buNone/>
              <a:defRPr sz="3700" b="1"/>
            </a:lvl2pPr>
            <a:lvl3pPr marL="1691640" indent="0">
              <a:buNone/>
              <a:defRPr sz="3330" b="1"/>
            </a:lvl3pPr>
            <a:lvl4pPr marL="2537460" indent="0">
              <a:buNone/>
              <a:defRPr sz="2960" b="1"/>
            </a:lvl4pPr>
            <a:lvl5pPr marL="3383280" indent="0">
              <a:buNone/>
              <a:defRPr sz="2960" b="1"/>
            </a:lvl5pPr>
            <a:lvl6pPr marL="4229100" indent="0">
              <a:buNone/>
              <a:defRPr sz="2960" b="1"/>
            </a:lvl6pPr>
            <a:lvl7pPr marL="5074920" indent="0">
              <a:buNone/>
              <a:defRPr sz="2960" b="1"/>
            </a:lvl7pPr>
            <a:lvl8pPr marL="5920740" indent="0">
              <a:buNone/>
              <a:defRPr sz="2960" b="1"/>
            </a:lvl8pPr>
            <a:lvl9pPr marL="6766560" indent="0">
              <a:buNone/>
              <a:defRPr sz="2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65208" y="8016240"/>
            <a:ext cx="7156429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563929" y="5379722"/>
            <a:ext cx="7191673" cy="2636518"/>
          </a:xfrm>
        </p:spPr>
        <p:txBody>
          <a:bodyPr anchor="b"/>
          <a:lstStyle>
            <a:lvl1pPr marL="0" indent="0">
              <a:buNone/>
              <a:defRPr sz="4440" b="1"/>
            </a:lvl1pPr>
            <a:lvl2pPr marL="845820" indent="0">
              <a:buNone/>
              <a:defRPr sz="3700" b="1"/>
            </a:lvl2pPr>
            <a:lvl3pPr marL="1691640" indent="0">
              <a:buNone/>
              <a:defRPr sz="3330" b="1"/>
            </a:lvl3pPr>
            <a:lvl4pPr marL="2537460" indent="0">
              <a:buNone/>
              <a:defRPr sz="2960" b="1"/>
            </a:lvl4pPr>
            <a:lvl5pPr marL="3383280" indent="0">
              <a:buNone/>
              <a:defRPr sz="2960" b="1"/>
            </a:lvl5pPr>
            <a:lvl6pPr marL="4229100" indent="0">
              <a:buNone/>
              <a:defRPr sz="2960" b="1"/>
            </a:lvl6pPr>
            <a:lvl7pPr marL="5074920" indent="0">
              <a:buNone/>
              <a:defRPr sz="2960" b="1"/>
            </a:lvl7pPr>
            <a:lvl8pPr marL="5920740" indent="0">
              <a:buNone/>
              <a:defRPr sz="2960" b="1"/>
            </a:lvl8pPr>
            <a:lvl9pPr marL="6766560" indent="0">
              <a:buNone/>
              <a:defRPr sz="2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563929" y="8016240"/>
            <a:ext cx="7191673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912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334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9079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463040"/>
            <a:ext cx="5455979" cy="5120640"/>
          </a:xfrm>
        </p:spPr>
        <p:txBody>
          <a:bodyPr anchor="b"/>
          <a:lstStyle>
            <a:lvl1pPr>
              <a:defRPr sz="5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1673" y="3159765"/>
            <a:ext cx="8563928" cy="15595600"/>
          </a:xfrm>
        </p:spPr>
        <p:txBody>
          <a:bodyPr/>
          <a:lstStyle>
            <a:lvl1pPr>
              <a:defRPr sz="5920"/>
            </a:lvl1pPr>
            <a:lvl2pPr>
              <a:defRPr sz="5180"/>
            </a:lvl2pPr>
            <a:lvl3pPr>
              <a:defRPr sz="4440"/>
            </a:lvl3pPr>
            <a:lvl4pPr>
              <a:defRPr sz="3700"/>
            </a:lvl4pPr>
            <a:lvl5pPr>
              <a:defRPr sz="3700"/>
            </a:lvl5pPr>
            <a:lvl6pPr>
              <a:defRPr sz="3700"/>
            </a:lvl6pPr>
            <a:lvl7pPr>
              <a:defRPr sz="3700"/>
            </a:lvl7pPr>
            <a:lvl8pPr>
              <a:defRPr sz="3700"/>
            </a:lvl8pPr>
            <a:lvl9pPr>
              <a:defRPr sz="3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65206" y="6583680"/>
            <a:ext cx="5455979" cy="12197082"/>
          </a:xfrm>
        </p:spPr>
        <p:txBody>
          <a:bodyPr/>
          <a:lstStyle>
            <a:lvl1pPr marL="0" indent="0">
              <a:buNone/>
              <a:defRPr sz="2960"/>
            </a:lvl1pPr>
            <a:lvl2pPr marL="845820" indent="0">
              <a:buNone/>
              <a:defRPr sz="2590"/>
            </a:lvl2pPr>
            <a:lvl3pPr marL="1691640" indent="0">
              <a:buNone/>
              <a:defRPr sz="2220"/>
            </a:lvl3pPr>
            <a:lvl4pPr marL="2537460" indent="0">
              <a:buNone/>
              <a:defRPr sz="1850"/>
            </a:lvl4pPr>
            <a:lvl5pPr marL="3383280" indent="0">
              <a:buNone/>
              <a:defRPr sz="1850"/>
            </a:lvl5pPr>
            <a:lvl6pPr marL="4229100" indent="0">
              <a:buNone/>
              <a:defRPr sz="1850"/>
            </a:lvl6pPr>
            <a:lvl7pPr marL="5074920" indent="0">
              <a:buNone/>
              <a:defRPr sz="1850"/>
            </a:lvl7pPr>
            <a:lvl8pPr marL="5920740" indent="0">
              <a:buNone/>
              <a:defRPr sz="1850"/>
            </a:lvl8pPr>
            <a:lvl9pPr marL="6766560" indent="0">
              <a:buNone/>
              <a:defRPr sz="1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726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463040"/>
            <a:ext cx="5455979" cy="5120640"/>
          </a:xfrm>
        </p:spPr>
        <p:txBody>
          <a:bodyPr anchor="b"/>
          <a:lstStyle>
            <a:lvl1pPr>
              <a:defRPr sz="5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191673" y="3159765"/>
            <a:ext cx="8563928" cy="15595600"/>
          </a:xfrm>
        </p:spPr>
        <p:txBody>
          <a:bodyPr anchor="t"/>
          <a:lstStyle>
            <a:lvl1pPr marL="0" indent="0">
              <a:buNone/>
              <a:defRPr sz="5920"/>
            </a:lvl1pPr>
            <a:lvl2pPr marL="845820" indent="0">
              <a:buNone/>
              <a:defRPr sz="5180"/>
            </a:lvl2pPr>
            <a:lvl3pPr marL="1691640" indent="0">
              <a:buNone/>
              <a:defRPr sz="4440"/>
            </a:lvl3pPr>
            <a:lvl4pPr marL="2537460" indent="0">
              <a:buNone/>
              <a:defRPr sz="3700"/>
            </a:lvl4pPr>
            <a:lvl5pPr marL="3383280" indent="0">
              <a:buNone/>
              <a:defRPr sz="3700"/>
            </a:lvl5pPr>
            <a:lvl6pPr marL="4229100" indent="0">
              <a:buNone/>
              <a:defRPr sz="3700"/>
            </a:lvl6pPr>
            <a:lvl7pPr marL="5074920" indent="0">
              <a:buNone/>
              <a:defRPr sz="3700"/>
            </a:lvl7pPr>
            <a:lvl8pPr marL="5920740" indent="0">
              <a:buNone/>
              <a:defRPr sz="3700"/>
            </a:lvl8pPr>
            <a:lvl9pPr marL="6766560" indent="0">
              <a:buNone/>
              <a:defRPr sz="3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65206" y="6583680"/>
            <a:ext cx="5455979" cy="12197082"/>
          </a:xfrm>
        </p:spPr>
        <p:txBody>
          <a:bodyPr/>
          <a:lstStyle>
            <a:lvl1pPr marL="0" indent="0">
              <a:buNone/>
              <a:defRPr sz="2960"/>
            </a:lvl1pPr>
            <a:lvl2pPr marL="845820" indent="0">
              <a:buNone/>
              <a:defRPr sz="2590"/>
            </a:lvl2pPr>
            <a:lvl3pPr marL="1691640" indent="0">
              <a:buNone/>
              <a:defRPr sz="2220"/>
            </a:lvl3pPr>
            <a:lvl4pPr marL="2537460" indent="0">
              <a:buNone/>
              <a:defRPr sz="1850"/>
            </a:lvl4pPr>
            <a:lvl5pPr marL="3383280" indent="0">
              <a:buNone/>
              <a:defRPr sz="1850"/>
            </a:lvl5pPr>
            <a:lvl6pPr marL="4229100" indent="0">
              <a:buNone/>
              <a:defRPr sz="1850"/>
            </a:lvl6pPr>
            <a:lvl7pPr marL="5074920" indent="0">
              <a:buNone/>
              <a:defRPr sz="1850"/>
            </a:lvl7pPr>
            <a:lvl8pPr marL="5920740" indent="0">
              <a:buNone/>
              <a:defRPr sz="1850"/>
            </a:lvl8pPr>
            <a:lvl9pPr marL="6766560" indent="0">
              <a:buNone/>
              <a:defRPr sz="1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234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63003" y="1168405"/>
            <a:ext cx="14590395" cy="4241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63003" y="5842000"/>
            <a:ext cx="14590395" cy="13924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63003" y="20340325"/>
            <a:ext cx="380619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603558" y="20340325"/>
            <a:ext cx="5709285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947208" y="20340325"/>
            <a:ext cx="380619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359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691640" rtl="0" eaLnBrk="1" latinLnBrk="0" hangingPunct="1">
        <a:lnSpc>
          <a:spcPct val="90000"/>
        </a:lnSpc>
        <a:spcBef>
          <a:spcPct val="0"/>
        </a:spcBef>
        <a:buNone/>
        <a:defRPr sz="81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22910" indent="-422910" algn="l" defTabSz="1691640" rtl="0" eaLnBrk="1" latinLnBrk="0" hangingPunct="1">
        <a:lnSpc>
          <a:spcPct val="90000"/>
        </a:lnSpc>
        <a:spcBef>
          <a:spcPts val="1850"/>
        </a:spcBef>
        <a:buFont typeface="Arial" panose="020B0604020202020204" pitchFamily="34" charset="0"/>
        <a:buChar char="•"/>
        <a:defRPr sz="5180" kern="1200">
          <a:solidFill>
            <a:schemeClr val="tx1"/>
          </a:solidFill>
          <a:latin typeface="+mn-lt"/>
          <a:ea typeface="+mn-ea"/>
          <a:cs typeface="+mn-cs"/>
        </a:defRPr>
      </a:lvl1pPr>
      <a:lvl2pPr marL="126873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4440" kern="1200">
          <a:solidFill>
            <a:schemeClr val="tx1"/>
          </a:solidFill>
          <a:latin typeface="+mn-lt"/>
          <a:ea typeface="+mn-ea"/>
          <a:cs typeface="+mn-cs"/>
        </a:defRPr>
      </a:lvl2pPr>
      <a:lvl3pPr marL="211455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3pPr>
      <a:lvl4pPr marL="296037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4pPr>
      <a:lvl5pPr marL="380619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5pPr>
      <a:lvl6pPr marL="465201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6pPr>
      <a:lvl7pPr marL="549783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7pPr>
      <a:lvl8pPr marL="634365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8pPr>
      <a:lvl9pPr marL="718947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1pPr>
      <a:lvl2pPr marL="84582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2pPr>
      <a:lvl3pPr marL="169164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3pPr>
      <a:lvl4pPr marL="253746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4pPr>
      <a:lvl5pPr marL="338328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5pPr>
      <a:lvl6pPr marL="422910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6pPr>
      <a:lvl7pPr marL="507492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7pPr>
      <a:lvl8pPr marL="592074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8pPr>
      <a:lvl9pPr marL="676656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81C328E-CEFB-DDFF-947A-47A0E991118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5F75EC65-31EB-05CB-506E-9C82B6B111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8919328"/>
              </p:ext>
            </p:extLst>
          </p:nvPr>
        </p:nvGraphicFramePr>
        <p:xfrm>
          <a:off x="1074384" y="1164687"/>
          <a:ext cx="11249544" cy="65451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372536">
                  <a:extLst>
                    <a:ext uri="{9D8B030D-6E8A-4147-A177-3AD203B41FA5}">
                      <a16:colId xmlns:a16="http://schemas.microsoft.com/office/drawing/2014/main" val="3870670535"/>
                    </a:ext>
                  </a:extLst>
                </a:gridCol>
                <a:gridCol w="1319089">
                  <a:extLst>
                    <a:ext uri="{9D8B030D-6E8A-4147-A177-3AD203B41FA5}">
                      <a16:colId xmlns:a16="http://schemas.microsoft.com/office/drawing/2014/main" val="1289942804"/>
                    </a:ext>
                  </a:extLst>
                </a:gridCol>
                <a:gridCol w="4247090">
                  <a:extLst>
                    <a:ext uri="{9D8B030D-6E8A-4147-A177-3AD203B41FA5}">
                      <a16:colId xmlns:a16="http://schemas.microsoft.com/office/drawing/2014/main" val="79581226"/>
                    </a:ext>
                  </a:extLst>
                </a:gridCol>
                <a:gridCol w="1310829">
                  <a:extLst>
                    <a:ext uri="{9D8B030D-6E8A-4147-A177-3AD203B41FA5}">
                      <a16:colId xmlns:a16="http://schemas.microsoft.com/office/drawing/2014/main" val="2964137976"/>
                    </a:ext>
                  </a:extLst>
                </a:gridCol>
              </a:tblGrid>
              <a:tr h="378496">
                <a:tc gridSpan="4">
                  <a:txBody>
                    <a:bodyPr/>
                    <a:lstStyle/>
                    <a:p>
                      <a:pPr algn="l"/>
                      <a:r>
                        <a:rPr lang="en-US" sz="2800" b="1" dirty="0">
                          <a:solidFill>
                            <a:sysClr val="windowText" lastClr="000000"/>
                          </a:solidFill>
                        </a:rPr>
                        <a:t>S3 Table. Homing rate parameter measures from single-cross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706344"/>
                  </a:ext>
                </a:extLst>
              </a:tr>
              <a:tr h="643866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1" i="1" dirty="0">
                          <a:solidFill>
                            <a:sysClr val="windowText" lastClr="000000"/>
                          </a:solidFill>
                        </a:rPr>
                        <a:t>nanos</a:t>
                      </a:r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-GD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80071094"/>
                  </a:ext>
                </a:extLst>
              </a:tr>
              <a:tr h="615056"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Inheritance rate, female GD outcrosses (fraction of whole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0.67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>
                          <a:solidFill>
                            <a:sysClr val="windowText" lastClr="000000"/>
                          </a:solidFill>
                        </a:rPr>
                        <a:t>Inheritance rate, male GD outcrosses (fraction of whole)</a:t>
                      </a:r>
                      <a:endParaRPr lang="en-US" sz="2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0.69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1865292"/>
                  </a:ext>
                </a:extLst>
              </a:tr>
              <a:tr h="425013"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N (outcrosses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12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>
                          <a:solidFill>
                            <a:sysClr val="windowText" lastClr="000000"/>
                          </a:solidFill>
                        </a:rPr>
                        <a:t>N (outcrosses)</a:t>
                      </a:r>
                      <a:endParaRPr lang="en-US" sz="2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>
                          <a:solidFill>
                            <a:sysClr val="windowText" lastClr="000000"/>
                          </a:solidFill>
                        </a:rPr>
                        <a:t>133</a:t>
                      </a:r>
                      <a:endParaRPr lang="en-US" sz="2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8222035"/>
                  </a:ext>
                </a:extLst>
              </a:tr>
              <a:tr h="410405"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# total larvae screened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884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>
                          <a:solidFill>
                            <a:sysClr val="windowText" lastClr="000000"/>
                          </a:solidFill>
                        </a:rPr>
                        <a:t># total larvae screened </a:t>
                      </a:r>
                      <a:endParaRPr lang="en-US" sz="2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>
                          <a:solidFill>
                            <a:sysClr val="windowText" lastClr="000000"/>
                          </a:solidFill>
                        </a:rPr>
                        <a:t>12683</a:t>
                      </a:r>
                      <a:endParaRPr lang="en-US" sz="2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5921815"/>
                  </a:ext>
                </a:extLst>
              </a:tr>
              <a:tr h="378496">
                <a:tc>
                  <a:txBody>
                    <a:bodyPr/>
                    <a:lstStyle/>
                    <a:p>
                      <a:r>
                        <a:rPr lang="en-US" sz="2000" dirty="0" err="1">
                          <a:solidFill>
                            <a:sysClr val="windowText" lastClr="000000"/>
                          </a:solidFill>
                        </a:rPr>
                        <a:t>st.</a:t>
                      </a:r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 dev. (of N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0.16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>
                          <a:solidFill>
                            <a:sysClr val="windowText" lastClr="000000"/>
                          </a:solidFill>
                        </a:rPr>
                        <a:t>st. dev. (of N)</a:t>
                      </a:r>
                      <a:endParaRPr lang="en-US" sz="2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>
                          <a:solidFill>
                            <a:sysClr val="windowText" lastClr="000000"/>
                          </a:solidFill>
                        </a:rPr>
                        <a:t>0.176</a:t>
                      </a:r>
                      <a:endParaRPr lang="en-US" sz="2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9747111"/>
                  </a:ext>
                </a:extLst>
              </a:tr>
              <a:tr h="45417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1" dirty="0" err="1">
                          <a:solidFill>
                            <a:sysClr val="windowText" lastClr="000000"/>
                          </a:solidFill>
                        </a:rPr>
                        <a:t>cF</a:t>
                      </a:r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*</a:t>
                      </a:r>
                      <a:r>
                        <a:rPr lang="en-US" sz="2000" b="1" dirty="0" err="1">
                          <a:solidFill>
                            <a:sysClr val="windowText" lastClr="000000"/>
                          </a:solidFill>
                        </a:rPr>
                        <a:t>chF</a:t>
                      </a:r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 (gene drive homing rate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0.36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1" dirty="0" err="1">
                          <a:solidFill>
                            <a:sysClr val="windowText" lastClr="000000"/>
                          </a:solidFill>
                        </a:rPr>
                        <a:t>cM</a:t>
                      </a:r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*</a:t>
                      </a:r>
                      <a:r>
                        <a:rPr lang="en-US" sz="2000" b="1" dirty="0" err="1">
                          <a:solidFill>
                            <a:sysClr val="windowText" lastClr="000000"/>
                          </a:solidFill>
                        </a:rPr>
                        <a:t>chM</a:t>
                      </a:r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 (gene drive homing rate)</a:t>
                      </a:r>
                      <a:endParaRPr lang="en-US" sz="2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0.41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8294922"/>
                  </a:ext>
                </a:extLst>
              </a:tr>
              <a:tr h="64312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1" i="1" dirty="0" err="1">
                          <a:solidFill>
                            <a:sysClr val="windowText" lastClr="000000"/>
                          </a:solidFill>
                        </a:rPr>
                        <a:t>zpg</a:t>
                      </a:r>
                      <a:r>
                        <a:rPr lang="en-US" sz="2000" b="1" i="1" dirty="0">
                          <a:solidFill>
                            <a:sysClr val="windowText" lastClr="000000"/>
                          </a:solidFill>
                        </a:rPr>
                        <a:t>-</a:t>
                      </a:r>
                      <a:r>
                        <a:rPr lang="en-US" sz="2000" b="1" i="0" dirty="0">
                          <a:solidFill>
                            <a:sysClr val="windowText" lastClr="000000"/>
                          </a:solidFill>
                        </a:rPr>
                        <a:t>GD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71162413"/>
                  </a:ext>
                </a:extLst>
              </a:tr>
              <a:tr h="615529"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Inheritance rate, female outcrosses (fraction of whole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0.59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>
                          <a:solidFill>
                            <a:sysClr val="windowText" lastClr="000000"/>
                          </a:solidFill>
                        </a:rPr>
                        <a:t>Inheritance rate, male outcrosses (fraction of whole)</a:t>
                      </a:r>
                      <a:endParaRPr lang="en-US" sz="2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0.55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3076230"/>
                  </a:ext>
                </a:extLst>
              </a:tr>
              <a:tr h="401265"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N (outcrosses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8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>
                          <a:solidFill>
                            <a:sysClr val="windowText" lastClr="000000"/>
                          </a:solidFill>
                        </a:rPr>
                        <a:t>N (outcrosses)</a:t>
                      </a:r>
                      <a:endParaRPr lang="en-US" sz="2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>
                          <a:solidFill>
                            <a:sysClr val="windowText" lastClr="000000"/>
                          </a:solidFill>
                        </a:rPr>
                        <a:t>108</a:t>
                      </a:r>
                      <a:endParaRPr lang="en-US" sz="2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8252320"/>
                  </a:ext>
                </a:extLst>
              </a:tr>
              <a:tr h="396100"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# total larvae screened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592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>
                          <a:solidFill>
                            <a:sysClr val="windowText" lastClr="000000"/>
                          </a:solidFill>
                        </a:rPr>
                        <a:t># total larvae screened </a:t>
                      </a:r>
                      <a:endParaRPr lang="en-US" sz="2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>
                          <a:solidFill>
                            <a:sysClr val="windowText" lastClr="000000"/>
                          </a:solidFill>
                        </a:rPr>
                        <a:t>7919</a:t>
                      </a:r>
                      <a:endParaRPr lang="en-US" sz="2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9533986"/>
                  </a:ext>
                </a:extLst>
              </a:tr>
              <a:tr h="378496">
                <a:tc>
                  <a:txBody>
                    <a:bodyPr/>
                    <a:lstStyle/>
                    <a:p>
                      <a:r>
                        <a:rPr lang="en-US" sz="2000" dirty="0" err="1">
                          <a:solidFill>
                            <a:sysClr val="windowText" lastClr="000000"/>
                          </a:solidFill>
                        </a:rPr>
                        <a:t>st.</a:t>
                      </a:r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 dev. (of N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0.11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>
                          <a:solidFill>
                            <a:sysClr val="windowText" lastClr="000000"/>
                          </a:solidFill>
                        </a:rPr>
                        <a:t>st. dev. (of N)</a:t>
                      </a:r>
                      <a:endParaRPr lang="en-US" sz="2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>
                          <a:solidFill>
                            <a:sysClr val="windowText" lastClr="000000"/>
                          </a:solidFill>
                        </a:rPr>
                        <a:t>0.136</a:t>
                      </a:r>
                      <a:endParaRPr lang="en-US" sz="2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1642456"/>
                  </a:ext>
                </a:extLst>
              </a:tr>
              <a:tr h="45837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1" dirty="0" err="1">
                          <a:solidFill>
                            <a:sysClr val="windowText" lastClr="000000"/>
                          </a:solidFill>
                        </a:rPr>
                        <a:t>cF</a:t>
                      </a:r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*</a:t>
                      </a:r>
                      <a:r>
                        <a:rPr lang="en-US" sz="2000" b="1" dirty="0" err="1">
                          <a:solidFill>
                            <a:sysClr val="windowText" lastClr="000000"/>
                          </a:solidFill>
                        </a:rPr>
                        <a:t>chF</a:t>
                      </a:r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 (gene drive homing rate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0.20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1" dirty="0" err="1">
                          <a:solidFill>
                            <a:sysClr val="windowText" lastClr="000000"/>
                          </a:solidFill>
                        </a:rPr>
                        <a:t>cM</a:t>
                      </a:r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*</a:t>
                      </a:r>
                      <a:r>
                        <a:rPr lang="en-US" sz="2000" b="1" dirty="0" err="1">
                          <a:solidFill>
                            <a:sysClr val="windowText" lastClr="000000"/>
                          </a:solidFill>
                        </a:rPr>
                        <a:t>chM</a:t>
                      </a:r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 (gene drive homing rate)</a:t>
                      </a:r>
                      <a:endParaRPr lang="en-US" sz="2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0.11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16332560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AE735D4-45B6-2200-C2BC-DFB554058BE4}"/>
              </a:ext>
            </a:extLst>
          </p:cNvPr>
          <p:cNvSpPr txBox="1"/>
          <p:nvPr/>
        </p:nvSpPr>
        <p:spPr>
          <a:xfrm>
            <a:off x="939800" y="7873447"/>
            <a:ext cx="11518712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400" dirty="0"/>
              <a:t>The inheritance rate data are based on those reported by Reid et al., 2022 [21]. GD inheritance was assessed following an initial outcross of GD positive male mosquitoes to ‘wild-type’ (HWE) females to obtain heterozygous OX-0 males and females. These were then reciprocally outcrossed to HWE to obtain GD bearing OX-1 individuals. The data in the table also include inheritance rates of (GD positive) OX-2 male and female individuals resulting from reciprocally outcrosses of OX-1 to HWE. </a:t>
            </a:r>
          </a:p>
        </p:txBody>
      </p:sp>
    </p:spTree>
    <p:extLst>
      <p:ext uri="{BB962C8B-B14F-4D97-AF65-F5344CB8AC3E}">
        <p14:creationId xmlns:p14="http://schemas.microsoft.com/office/powerpoint/2010/main" val="15585938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462</TotalTime>
  <Words>262</Words>
  <Application>Microsoft Office PowerPoint</Application>
  <PresentationFormat>Custom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ach Speth</dc:creator>
  <cp:lastModifiedBy>Franz, Alexander</cp:lastModifiedBy>
  <cp:revision>432</cp:revision>
  <dcterms:created xsi:type="dcterms:W3CDTF">2024-06-26T16:03:17Z</dcterms:created>
  <dcterms:modified xsi:type="dcterms:W3CDTF">2025-05-09T15:18:07Z</dcterms:modified>
</cp:coreProperties>
</file>